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510" r:id="rId2"/>
    <p:sldId id="503" r:id="rId3"/>
    <p:sldId id="517" r:id="rId4"/>
    <p:sldId id="505" r:id="rId5"/>
    <p:sldId id="504" r:id="rId6"/>
    <p:sldId id="514" r:id="rId7"/>
    <p:sldId id="509" r:id="rId8"/>
    <p:sldId id="506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840"/>
    <p:restoredTop sz="95878"/>
  </p:normalViewPr>
  <p:slideViewPr>
    <p:cSldViewPr snapToGrid="0" snapToObjects="1">
      <p:cViewPr>
        <p:scale>
          <a:sx n="110" d="100"/>
          <a:sy n="110" d="100"/>
        </p:scale>
        <p:origin x="1080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938888-2CE0-5445-A139-A3C5BB49AC59}" type="datetimeFigureOut">
              <a:rPr lang="en-US" smtClean="0"/>
              <a:t>2/1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FECD84-989B-4E4E-88DD-0DA4AF58B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7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 lysate western blots run on 12% SDS-PAGE gels transferred to nitrocellulose membranes for blotting. 10µg protein were loaded per lane. See methods for more detail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8584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0782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4895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TA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650031-787D-F84F-B24B-E5E8DF12492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4845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oleus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79097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oleus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  <a:p>
            <a:r>
              <a:rPr lang="en-US" dirty="0"/>
              <a:t>SC (1), SR (1), VC (2), VR (2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44384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oleus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FECD84-989B-4E4E-88DD-0DA4AF58B3F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13202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oleus lysate western blots run on 12% SDS-PAGE gels transferred to nitrocellulose membranes for blotting. 10µg protein were loaded per lane. See methods for more detail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650031-787D-F84F-B24B-E5E8DF12492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41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F39960-1761-5D42-80F3-3561B57033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A87FFD1-E668-A04C-8914-CCFB8AF56C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E791AE-1972-E445-9893-22D5D854A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A4ADF5-E75E-974E-98BD-F164C301A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6BF77-B035-7346-A91B-4D320B247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493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7C796-C689-EA4C-9E33-971B3EC173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64C35D-5F77-4C40-849B-CDE6EB4CF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EB3839-DBB7-0A48-8AD6-365709134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F0A608-C650-F248-952F-60AD59076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8812A9-396C-2A45-A86C-58AA789B2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613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F4F989-8754-0A43-909B-A337AB28E5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8FDB76-5E8D-D441-B980-DC435ADC3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269FD-B9AA-174F-B317-659D54157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A17776-C433-7944-BDB2-9AA795193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55FF4B-C086-BA48-B2A1-085085F58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045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6831D0-4F86-6B4B-9624-3092B9C94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07C97E-12DF-C643-883A-8718F0E90F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D346F-CDFD-1149-84D3-45C579056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8483E6-3341-AF40-98C2-39D8AD9B5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706FA0-44AE-3640-97CB-F210EBFAB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142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116499-2782-D542-BDFA-20347BA1F5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08172-C18E-C640-98C9-69BAFBC66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7A15B-8B7B-C449-A69E-F678F3EF9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11194-A8E2-DF4D-80F0-81B7B3EB1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657BBF-32C7-DE45-BDB1-CA0A4F2B5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383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B2095-D50D-9C43-B8CB-053B89D973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AE840A-0DEB-F04A-873F-9302D2D051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5C8BF0-80C6-3E45-AC8A-AC47CD35D8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76A564-D27C-424A-9FD0-1D886D965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EE9414-868A-4544-8D06-7B82B4B3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06C590-C2C0-CB4D-A4C9-E30DD7209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009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4AE0F-96C4-FB46-9FF5-F80B0664B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B630A7-187C-5943-A676-8227DFEF19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97DC3B-9203-414B-9E6D-72066A7F2D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ACE2B1-E832-1B4B-8BB3-FE6CAD297A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61A7720-4D2F-FB45-A466-01B0878908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9ACF58-3835-C94C-8251-B3FD78F1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27BEBA-E506-9440-B489-3248DEA5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C99AE4-48C1-1343-80AC-3507A43DA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149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EFE4C-30D3-CF49-8448-AD41F5018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9B06E76-FD21-5448-AA7A-E9338800C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9992CD-C9BF-0942-AB95-BC119A43A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1EDE71-23D6-F34B-910A-27E7AB7B8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263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3FA8C3-D456-CE4B-9235-638C3DFA0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C8A152-13BF-8B46-86F7-3D49DFD5F1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8D13AA-00FA-B849-A795-93A9B07453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604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4050B-65A3-5A4C-A968-8C8DEA8F57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D7E7DD-BD1E-A044-83FA-1AB5982365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16FF52-DF47-1441-8C70-AB3465DA24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60EF18-5582-7540-9649-C49EE4EAF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F92CD8-D365-D94A-9432-24A5D1219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F7D463-9FAA-BC48-B8C4-A01EEE33A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479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27BA9-46FC-4B49-9FDA-7E4858EA9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D5BC062-148E-CE42-8689-FE4F021664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D420EC-6078-FA40-A602-60B10B7214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2B93BC-8D63-8744-8864-5CDD1A1F1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BE5C33-BF83-7747-BC81-8C119FBD2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C62F92-DAE7-254B-86F1-AAE12199E2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75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F84904-B997-D345-AE85-4475D7F13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270F53-2621-3545-87A2-95188D5CD5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367E7E-F9FF-364C-957B-DE6C7B7E1A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813109-9781-0940-8DB0-97F3B61358AA}" type="datetimeFigureOut">
              <a:rPr lang="en-US" smtClean="0"/>
              <a:t>2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34C1F9-018B-5345-8446-30F9C37FEC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4C754C-1C10-F54E-97CD-49FE051655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0FCE4-6521-DE46-948E-9396EEB0FA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30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127EB07-68C0-DD46-8136-48869EFD9A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2472" b="-1"/>
          <a:stretch/>
        </p:blipFill>
        <p:spPr>
          <a:xfrm>
            <a:off x="1330634" y="914400"/>
            <a:ext cx="5270281" cy="4279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731402D-7758-C24E-8DB3-7F755FDB1054}"/>
              </a:ext>
            </a:extLst>
          </p:cNvPr>
          <p:cNvSpPr txBox="1"/>
          <p:nvPr/>
        </p:nvSpPr>
        <p:spPr>
          <a:xfrm>
            <a:off x="7149137" y="785737"/>
            <a:ext cx="2102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M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7763DE-6E0A-8146-8719-C7D661271BE3}"/>
              </a:ext>
            </a:extLst>
          </p:cNvPr>
          <p:cNvSpPr txBox="1"/>
          <p:nvPr/>
        </p:nvSpPr>
        <p:spPr>
          <a:xfrm>
            <a:off x="7149136" y="1727207"/>
            <a:ext cx="2102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Q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88A5028-4A48-D641-895A-C9C2BE4B0B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26509" y="2731373"/>
            <a:ext cx="5274406" cy="139525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E9E587A-B036-EF44-8909-B01A3E49B39D}"/>
              </a:ext>
            </a:extLst>
          </p:cNvPr>
          <p:cNvSpPr txBox="1"/>
          <p:nvPr/>
        </p:nvSpPr>
        <p:spPr>
          <a:xfrm>
            <a:off x="7149136" y="2834604"/>
            <a:ext cx="2102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35AFCED-3C6C-5E42-A242-DA7B758BBC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8762" y="4199215"/>
            <a:ext cx="5270282" cy="97009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12EC208A-D29D-1448-98AA-20E059B85FAE}"/>
              </a:ext>
            </a:extLst>
          </p:cNvPr>
          <p:cNvSpPr txBox="1"/>
          <p:nvPr/>
        </p:nvSpPr>
        <p:spPr>
          <a:xfrm>
            <a:off x="7131388" y="4852453"/>
            <a:ext cx="2102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FN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2A5E64CA-404B-3D44-A697-5E16CC3C808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1393"/>
          <a:stretch/>
        </p:blipFill>
        <p:spPr>
          <a:xfrm>
            <a:off x="1341354" y="5230260"/>
            <a:ext cx="5300693" cy="142446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4073CA1-BAB2-7A4A-B723-E5FB16DD8BFB}"/>
              </a:ext>
            </a:extLst>
          </p:cNvPr>
          <p:cNvSpPr txBox="1"/>
          <p:nvPr/>
        </p:nvSpPr>
        <p:spPr>
          <a:xfrm>
            <a:off x="7131388" y="5341158"/>
            <a:ext cx="2102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AC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BEF9380-46F0-8548-AE45-1C37607F56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41354" y="1354249"/>
            <a:ext cx="5255437" cy="130096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14F857C6-48DB-AB41-9A94-7F2B3C5D07F7}"/>
              </a:ext>
            </a:extLst>
          </p:cNvPr>
          <p:cNvSpPr txBox="1"/>
          <p:nvPr/>
        </p:nvSpPr>
        <p:spPr>
          <a:xfrm>
            <a:off x="2390634" y="210167"/>
            <a:ext cx="3106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3137381-BAF5-DC47-B9B3-9A7F0148EDCF}"/>
              </a:ext>
            </a:extLst>
          </p:cNvPr>
          <p:cNvSpPr txBox="1"/>
          <p:nvPr/>
        </p:nvSpPr>
        <p:spPr>
          <a:xfrm>
            <a:off x="4328938" y="209586"/>
            <a:ext cx="3106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3DED701-D858-4D42-93C4-6358B58F42B8}"/>
              </a:ext>
            </a:extLst>
          </p:cNvPr>
          <p:cNvSpPr txBox="1"/>
          <p:nvPr/>
        </p:nvSpPr>
        <p:spPr>
          <a:xfrm>
            <a:off x="1715970" y="538404"/>
            <a:ext cx="3106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CL CL RL RL R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B1F4F22-E69F-B74F-A0FE-03B06B2549FD}"/>
              </a:ext>
            </a:extLst>
          </p:cNvPr>
          <p:cNvSpPr txBox="1"/>
          <p:nvPr/>
        </p:nvSpPr>
        <p:spPr>
          <a:xfrm>
            <a:off x="3835368" y="543907"/>
            <a:ext cx="31065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 RL RL CL CL C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4B7F73-CD6F-6044-879C-4433061A0628}"/>
              </a:ext>
            </a:extLst>
          </p:cNvPr>
          <p:cNvSpPr txBox="1"/>
          <p:nvPr/>
        </p:nvSpPr>
        <p:spPr>
          <a:xfrm>
            <a:off x="782412" y="74110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5AB5FCF-7CA9-1E49-87BC-257144E6D0FA}"/>
              </a:ext>
            </a:extLst>
          </p:cNvPr>
          <p:cNvSpPr txBox="1"/>
          <p:nvPr/>
        </p:nvSpPr>
        <p:spPr>
          <a:xfrm>
            <a:off x="773460" y="103397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3120D8A-8BAD-B44F-B2D9-E830FEE71F40}"/>
              </a:ext>
            </a:extLst>
          </p:cNvPr>
          <p:cNvSpPr txBox="1"/>
          <p:nvPr/>
        </p:nvSpPr>
        <p:spPr>
          <a:xfrm>
            <a:off x="760618" y="134235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B2C4BCA-BD90-4E4B-B47B-3B182CA8322D}"/>
              </a:ext>
            </a:extLst>
          </p:cNvPr>
          <p:cNvSpPr txBox="1"/>
          <p:nvPr/>
        </p:nvSpPr>
        <p:spPr>
          <a:xfrm>
            <a:off x="755258" y="185219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49666BA-6BE2-4549-A770-FF973F83B1F3}"/>
              </a:ext>
            </a:extLst>
          </p:cNvPr>
          <p:cNvSpPr txBox="1"/>
          <p:nvPr/>
        </p:nvSpPr>
        <p:spPr>
          <a:xfrm>
            <a:off x="755257" y="265637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AED2F9A-743F-EF4E-9B30-E9E99C84D3F9}"/>
              </a:ext>
            </a:extLst>
          </p:cNvPr>
          <p:cNvSpPr txBox="1"/>
          <p:nvPr/>
        </p:nvSpPr>
        <p:spPr>
          <a:xfrm>
            <a:off x="752053" y="332516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C39368E-DFC1-B54A-A823-893E2712396B}"/>
              </a:ext>
            </a:extLst>
          </p:cNvPr>
          <p:cNvSpPr txBox="1"/>
          <p:nvPr/>
        </p:nvSpPr>
        <p:spPr>
          <a:xfrm>
            <a:off x="750694" y="3685487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4C40C99-0CC7-2743-AE6E-6FCF142EEEDE}"/>
              </a:ext>
            </a:extLst>
          </p:cNvPr>
          <p:cNvSpPr txBox="1"/>
          <p:nvPr/>
        </p:nvSpPr>
        <p:spPr>
          <a:xfrm>
            <a:off x="760617" y="391740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6F99C7-510C-204C-9A15-1C2BBC18865B}"/>
              </a:ext>
            </a:extLst>
          </p:cNvPr>
          <p:cNvSpPr txBox="1"/>
          <p:nvPr/>
        </p:nvSpPr>
        <p:spPr>
          <a:xfrm>
            <a:off x="760617" y="4714600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5A31366-6E7F-D041-993D-9B9E606DB346}"/>
              </a:ext>
            </a:extLst>
          </p:cNvPr>
          <p:cNvSpPr txBox="1"/>
          <p:nvPr/>
        </p:nvSpPr>
        <p:spPr>
          <a:xfrm>
            <a:off x="746165" y="494554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D851C6D-5603-9A47-96DF-75B75B9B768E}"/>
              </a:ext>
            </a:extLst>
          </p:cNvPr>
          <p:cNvSpPr txBox="1"/>
          <p:nvPr/>
        </p:nvSpPr>
        <p:spPr>
          <a:xfrm>
            <a:off x="746164" y="4460741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AD03AA4-EC74-A344-BF1F-D11F36EBE64D}"/>
              </a:ext>
            </a:extLst>
          </p:cNvPr>
          <p:cNvSpPr txBox="1"/>
          <p:nvPr/>
        </p:nvSpPr>
        <p:spPr>
          <a:xfrm>
            <a:off x="746164" y="4239781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F215E55-434E-5249-A4DD-A7FB94853659}"/>
              </a:ext>
            </a:extLst>
          </p:cNvPr>
          <p:cNvSpPr txBox="1"/>
          <p:nvPr/>
        </p:nvSpPr>
        <p:spPr>
          <a:xfrm>
            <a:off x="755257" y="518595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18FFCCB-E827-B941-B260-DCEAC7AFD20A}"/>
              </a:ext>
            </a:extLst>
          </p:cNvPr>
          <p:cNvSpPr txBox="1"/>
          <p:nvPr/>
        </p:nvSpPr>
        <p:spPr>
          <a:xfrm>
            <a:off x="761849" y="585470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E31D11C-3F8A-BC49-9FE6-F1A4EE79701C}"/>
              </a:ext>
            </a:extLst>
          </p:cNvPr>
          <p:cNvSpPr txBox="1"/>
          <p:nvPr/>
        </p:nvSpPr>
        <p:spPr>
          <a:xfrm>
            <a:off x="771044" y="637001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DF132276-6639-6744-966E-BD1FEFD1B47E}"/>
              </a:ext>
            </a:extLst>
          </p:cNvPr>
          <p:cNvCxnSpPr/>
          <p:nvPr/>
        </p:nvCxnSpPr>
        <p:spPr>
          <a:xfrm>
            <a:off x="1715970" y="538404"/>
            <a:ext cx="2034227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EDCBD1D4-DCC8-064D-8224-E31AD05D97F8}"/>
              </a:ext>
            </a:extLst>
          </p:cNvPr>
          <p:cNvCxnSpPr/>
          <p:nvPr/>
        </p:nvCxnSpPr>
        <p:spPr>
          <a:xfrm>
            <a:off x="3835368" y="538404"/>
            <a:ext cx="203422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28602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141D3BA-E8F1-4040-9486-F12C09681F4E}"/>
              </a:ext>
            </a:extLst>
          </p:cNvPr>
          <p:cNvSpPr txBox="1"/>
          <p:nvPr/>
        </p:nvSpPr>
        <p:spPr>
          <a:xfrm>
            <a:off x="7622179" y="4534248"/>
            <a:ext cx="1217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X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DEBB45F-EC69-C749-9F99-DB4D826C4C4C}"/>
              </a:ext>
            </a:extLst>
          </p:cNvPr>
          <p:cNvSpPr txBox="1"/>
          <p:nvPr/>
        </p:nvSpPr>
        <p:spPr>
          <a:xfrm>
            <a:off x="7530904" y="2110682"/>
            <a:ext cx="1217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C1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5D21BA-80E6-4648-AC16-884BC3BB497A}"/>
              </a:ext>
            </a:extLst>
          </p:cNvPr>
          <p:cNvSpPr txBox="1"/>
          <p:nvPr/>
        </p:nvSpPr>
        <p:spPr>
          <a:xfrm>
            <a:off x="7530904" y="3059668"/>
            <a:ext cx="1217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2A3A0EE-1986-F54A-9EE7-B20698FF9E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7408"/>
          <a:stretch/>
        </p:blipFill>
        <p:spPr>
          <a:xfrm>
            <a:off x="1557662" y="1938772"/>
            <a:ext cx="5711569" cy="71315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FFC5415-DDBA-2A42-9C8D-14DACA440AD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7228"/>
          <a:stretch/>
        </p:blipFill>
        <p:spPr>
          <a:xfrm>
            <a:off x="1542067" y="4142068"/>
            <a:ext cx="5742757" cy="144704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2565B84-646F-394C-8B37-8C9FF83DA2A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36623"/>
          <a:stretch/>
        </p:blipFill>
        <p:spPr>
          <a:xfrm>
            <a:off x="1557661" y="2743200"/>
            <a:ext cx="5718758" cy="1307592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FC25451-CD20-2549-902F-DB9FDE3F9614}"/>
              </a:ext>
            </a:extLst>
          </p:cNvPr>
          <p:cNvSpPr txBox="1"/>
          <p:nvPr/>
        </p:nvSpPr>
        <p:spPr>
          <a:xfrm>
            <a:off x="2702623" y="1217091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3288364-9F99-CA46-806A-3577E18F24AD}"/>
              </a:ext>
            </a:extLst>
          </p:cNvPr>
          <p:cNvSpPr txBox="1"/>
          <p:nvPr/>
        </p:nvSpPr>
        <p:spPr>
          <a:xfrm>
            <a:off x="4651040" y="1209388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D7D8C66-C2C5-334A-AABE-D86465B0222E}"/>
              </a:ext>
            </a:extLst>
          </p:cNvPr>
          <p:cNvSpPr txBox="1"/>
          <p:nvPr/>
        </p:nvSpPr>
        <p:spPr>
          <a:xfrm>
            <a:off x="1909823" y="1613060"/>
            <a:ext cx="2931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 CL CL  RL RL  R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1ED8174-B177-E24F-8F7D-D532C5585D78}"/>
              </a:ext>
            </a:extLst>
          </p:cNvPr>
          <p:cNvSpPr txBox="1"/>
          <p:nvPr/>
        </p:nvSpPr>
        <p:spPr>
          <a:xfrm>
            <a:off x="4146156" y="1613060"/>
            <a:ext cx="3392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 RL  RL  CL  CL  C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A6C61D0-F0C1-554E-9206-A55ABEFB3FDA}"/>
              </a:ext>
            </a:extLst>
          </p:cNvPr>
          <p:cNvSpPr txBox="1"/>
          <p:nvPr/>
        </p:nvSpPr>
        <p:spPr>
          <a:xfrm>
            <a:off x="953178" y="179772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E54C295-1387-0249-B5BC-F4840CAC0F00}"/>
              </a:ext>
            </a:extLst>
          </p:cNvPr>
          <p:cNvSpPr txBox="1"/>
          <p:nvPr/>
        </p:nvSpPr>
        <p:spPr>
          <a:xfrm>
            <a:off x="952199" y="201435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B438CA5-A0D2-FB40-BADD-B323E4659CD2}"/>
              </a:ext>
            </a:extLst>
          </p:cNvPr>
          <p:cNvSpPr txBox="1"/>
          <p:nvPr/>
        </p:nvSpPr>
        <p:spPr>
          <a:xfrm>
            <a:off x="951035" y="226352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3FFCBAC-2C8D-AF40-B317-500B9712C071}"/>
              </a:ext>
            </a:extLst>
          </p:cNvPr>
          <p:cNvSpPr txBox="1"/>
          <p:nvPr/>
        </p:nvSpPr>
        <p:spPr>
          <a:xfrm>
            <a:off x="951034" y="2992375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B0703F9-322A-D345-A68A-78F716194798}"/>
              </a:ext>
            </a:extLst>
          </p:cNvPr>
          <p:cNvSpPr txBox="1"/>
          <p:nvPr/>
        </p:nvSpPr>
        <p:spPr>
          <a:xfrm>
            <a:off x="951033" y="368916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5FEA3BD-8A2C-1847-802E-F8F42441A786}"/>
              </a:ext>
            </a:extLst>
          </p:cNvPr>
          <p:cNvSpPr txBox="1"/>
          <p:nvPr/>
        </p:nvSpPr>
        <p:spPr>
          <a:xfrm>
            <a:off x="951033" y="404561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DA48EAF-5832-CA45-816C-87420FA98419}"/>
              </a:ext>
            </a:extLst>
          </p:cNvPr>
          <p:cNvSpPr txBox="1"/>
          <p:nvPr/>
        </p:nvSpPr>
        <p:spPr>
          <a:xfrm>
            <a:off x="951033" y="427624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04DC963-4FC9-D741-AD09-6C457791B684}"/>
              </a:ext>
            </a:extLst>
          </p:cNvPr>
          <p:cNvSpPr txBox="1"/>
          <p:nvPr/>
        </p:nvSpPr>
        <p:spPr>
          <a:xfrm>
            <a:off x="951033" y="453424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1C44B0D-1C12-EA44-B997-CC4930CF5641}"/>
              </a:ext>
            </a:extLst>
          </p:cNvPr>
          <p:cNvSpPr txBox="1"/>
          <p:nvPr/>
        </p:nvSpPr>
        <p:spPr>
          <a:xfrm>
            <a:off x="951033" y="4800381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985B806-C53B-0848-A276-D65AB9C5E85A}"/>
              </a:ext>
            </a:extLst>
          </p:cNvPr>
          <p:cNvSpPr txBox="1"/>
          <p:nvPr/>
        </p:nvSpPr>
        <p:spPr>
          <a:xfrm>
            <a:off x="951033" y="527376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54EDDC8-118E-634E-9498-8C8DDA0985C7}"/>
              </a:ext>
            </a:extLst>
          </p:cNvPr>
          <p:cNvCxnSpPr>
            <a:cxnSpLocks/>
          </p:cNvCxnSpPr>
          <p:nvPr/>
        </p:nvCxnSpPr>
        <p:spPr>
          <a:xfrm>
            <a:off x="1993762" y="1611642"/>
            <a:ext cx="2152394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C7FFD24-5049-8046-8C01-B0106A48ADA8}"/>
              </a:ext>
            </a:extLst>
          </p:cNvPr>
          <p:cNvCxnSpPr>
            <a:cxnSpLocks/>
          </p:cNvCxnSpPr>
          <p:nvPr/>
        </p:nvCxnSpPr>
        <p:spPr>
          <a:xfrm>
            <a:off x="4266284" y="1611642"/>
            <a:ext cx="2215539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62162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90DE1DC-24FA-FD45-AA8D-C4F078B6100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5977"/>
          <a:stretch/>
        </p:blipFill>
        <p:spPr>
          <a:xfrm>
            <a:off x="2415547" y="2578062"/>
            <a:ext cx="6563196" cy="123191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123215F-84D2-4E4F-80B3-67DB0F213895}"/>
              </a:ext>
            </a:extLst>
          </p:cNvPr>
          <p:cNvSpPr txBox="1"/>
          <p:nvPr/>
        </p:nvSpPr>
        <p:spPr>
          <a:xfrm>
            <a:off x="9134454" y="3148555"/>
            <a:ext cx="1507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2805414-CC59-D340-BCC8-36B693E92B9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40571" b="26707"/>
          <a:stretch/>
        </p:blipFill>
        <p:spPr>
          <a:xfrm>
            <a:off x="2389222" y="3847453"/>
            <a:ext cx="6628839" cy="150533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EA2F477-E808-0D45-B181-ADCA296AD7FC}"/>
              </a:ext>
            </a:extLst>
          </p:cNvPr>
          <p:cNvSpPr txBox="1"/>
          <p:nvPr/>
        </p:nvSpPr>
        <p:spPr>
          <a:xfrm>
            <a:off x="9134454" y="4455675"/>
            <a:ext cx="1507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U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416B2B-EEA1-F944-9E60-50FAE264573D}"/>
              </a:ext>
            </a:extLst>
          </p:cNvPr>
          <p:cNvSpPr txBox="1"/>
          <p:nvPr/>
        </p:nvSpPr>
        <p:spPr>
          <a:xfrm>
            <a:off x="9123038" y="1567882"/>
            <a:ext cx="1507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C1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E6B7E3A-7E9C-6D44-A28A-DD49ACE46E9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7034"/>
          <a:stretch/>
        </p:blipFill>
        <p:spPr>
          <a:xfrm>
            <a:off x="2485904" y="1138402"/>
            <a:ext cx="6415778" cy="121959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2FBE3CE-CE73-2A45-93C3-8251BED70B9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6019" b="26496"/>
          <a:stretch/>
        </p:blipFill>
        <p:spPr>
          <a:xfrm>
            <a:off x="2349904" y="5470243"/>
            <a:ext cx="6628839" cy="121959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F65D20E-F640-1F40-A4C7-D9851E8E840B}"/>
              </a:ext>
            </a:extLst>
          </p:cNvPr>
          <p:cNvSpPr txBox="1"/>
          <p:nvPr/>
        </p:nvSpPr>
        <p:spPr>
          <a:xfrm>
            <a:off x="9134454" y="5578129"/>
            <a:ext cx="1507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A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D27FFD-BB2B-E345-BB19-7EBB7F14A91D}"/>
              </a:ext>
            </a:extLst>
          </p:cNvPr>
          <p:cNvSpPr txBox="1"/>
          <p:nvPr/>
        </p:nvSpPr>
        <p:spPr>
          <a:xfrm>
            <a:off x="3562440" y="284050"/>
            <a:ext cx="1507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13A0B50-C24A-5A42-BCEE-DBFA71F54DD3}"/>
              </a:ext>
            </a:extLst>
          </p:cNvPr>
          <p:cNvSpPr txBox="1"/>
          <p:nvPr/>
        </p:nvSpPr>
        <p:spPr>
          <a:xfrm>
            <a:off x="6742962" y="284051"/>
            <a:ext cx="1507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0078BF-EE44-8C47-B7CE-0F159F3956C0}"/>
              </a:ext>
            </a:extLst>
          </p:cNvPr>
          <p:cNvSpPr txBox="1"/>
          <p:nvPr/>
        </p:nvSpPr>
        <p:spPr>
          <a:xfrm>
            <a:off x="2835110" y="771800"/>
            <a:ext cx="32608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   CL   CL  RL   RL  R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F8F7DE2-65D7-A043-96A1-0865E10DAFC8}"/>
              </a:ext>
            </a:extLst>
          </p:cNvPr>
          <p:cNvSpPr txBox="1"/>
          <p:nvPr/>
        </p:nvSpPr>
        <p:spPr>
          <a:xfrm>
            <a:off x="5910188" y="789055"/>
            <a:ext cx="36736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 CL   CL   RL  RL  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E6095B7-F789-D44E-8DB5-4A558165F0F1}"/>
              </a:ext>
            </a:extLst>
          </p:cNvPr>
          <p:cNvSpPr txBox="1"/>
          <p:nvPr/>
        </p:nvSpPr>
        <p:spPr>
          <a:xfrm>
            <a:off x="1745605" y="104009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73498DD-BCF0-FA41-B9D4-4711C23D0F18}"/>
              </a:ext>
            </a:extLst>
          </p:cNvPr>
          <p:cNvSpPr txBox="1"/>
          <p:nvPr/>
        </p:nvSpPr>
        <p:spPr>
          <a:xfrm>
            <a:off x="1745605" y="134221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E44336A-A8D7-1D45-BB07-B17D47668D4D}"/>
              </a:ext>
            </a:extLst>
          </p:cNvPr>
          <p:cNvSpPr txBox="1"/>
          <p:nvPr/>
        </p:nvSpPr>
        <p:spPr>
          <a:xfrm>
            <a:off x="1745848" y="156788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AA5A169-FA6D-3F48-8AA6-412A4A7EA359}"/>
              </a:ext>
            </a:extLst>
          </p:cNvPr>
          <p:cNvSpPr txBox="1"/>
          <p:nvPr/>
        </p:nvSpPr>
        <p:spPr>
          <a:xfrm>
            <a:off x="1745605" y="185907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62BAE51-B310-644D-86C3-0C3B833033F1}"/>
              </a:ext>
            </a:extLst>
          </p:cNvPr>
          <p:cNvSpPr txBox="1"/>
          <p:nvPr/>
        </p:nvSpPr>
        <p:spPr>
          <a:xfrm>
            <a:off x="1745604" y="2476350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1DF81DB-C78C-EC43-8F9D-84E249DA89B5}"/>
              </a:ext>
            </a:extLst>
          </p:cNvPr>
          <p:cNvSpPr txBox="1"/>
          <p:nvPr/>
        </p:nvSpPr>
        <p:spPr>
          <a:xfrm>
            <a:off x="1745604" y="3010425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3D0EEE-1A0B-C949-B5F9-548FBEFDEA83}"/>
              </a:ext>
            </a:extLst>
          </p:cNvPr>
          <p:cNvSpPr txBox="1"/>
          <p:nvPr/>
        </p:nvSpPr>
        <p:spPr>
          <a:xfrm>
            <a:off x="1745604" y="3973297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9953D94-E152-E042-A6A5-17C7F759505D}"/>
              </a:ext>
            </a:extLst>
          </p:cNvPr>
          <p:cNvSpPr txBox="1"/>
          <p:nvPr/>
        </p:nvSpPr>
        <p:spPr>
          <a:xfrm>
            <a:off x="1745603" y="493616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AA25688-E317-9C43-8E21-DE1EA4048916}"/>
              </a:ext>
            </a:extLst>
          </p:cNvPr>
          <p:cNvSpPr txBox="1"/>
          <p:nvPr/>
        </p:nvSpPr>
        <p:spPr>
          <a:xfrm>
            <a:off x="1745602" y="531620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A9981FA-B04E-3B4D-A24F-8082203D94DA}"/>
              </a:ext>
            </a:extLst>
          </p:cNvPr>
          <p:cNvSpPr txBox="1"/>
          <p:nvPr/>
        </p:nvSpPr>
        <p:spPr>
          <a:xfrm>
            <a:off x="1745602" y="624575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0061576-DE82-3F4A-A2BA-7AE4157E977B}"/>
              </a:ext>
            </a:extLst>
          </p:cNvPr>
          <p:cNvCxnSpPr>
            <a:cxnSpLocks/>
          </p:cNvCxnSpPr>
          <p:nvPr/>
        </p:nvCxnSpPr>
        <p:spPr>
          <a:xfrm>
            <a:off x="5910188" y="771800"/>
            <a:ext cx="2574055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71AD611-8E5B-034A-83EE-D9A37FCEF959}"/>
              </a:ext>
            </a:extLst>
          </p:cNvPr>
          <p:cNvCxnSpPr>
            <a:cxnSpLocks/>
          </p:cNvCxnSpPr>
          <p:nvPr/>
        </p:nvCxnSpPr>
        <p:spPr>
          <a:xfrm>
            <a:off x="2969919" y="771800"/>
            <a:ext cx="2493332" cy="17255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977352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1FACB7-5716-454D-B515-7CB9EC481D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1599" y="1555922"/>
            <a:ext cx="5985934" cy="101182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14926A5-6420-DE47-8483-B978D52393BC}"/>
              </a:ext>
            </a:extLst>
          </p:cNvPr>
          <p:cNvSpPr txBox="1"/>
          <p:nvPr/>
        </p:nvSpPr>
        <p:spPr>
          <a:xfrm>
            <a:off x="8837151" y="1847639"/>
            <a:ext cx="1439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C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0DAE5F8-1BA6-A148-966F-55C5131D03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83130" y="2600906"/>
            <a:ext cx="5996445" cy="120944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7001489-6745-5041-8FCC-9EDEFD7F5C26}"/>
              </a:ext>
            </a:extLst>
          </p:cNvPr>
          <p:cNvSpPr txBox="1"/>
          <p:nvPr/>
        </p:nvSpPr>
        <p:spPr>
          <a:xfrm>
            <a:off x="8837151" y="3316769"/>
            <a:ext cx="1439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D2D47B7-A6C9-664A-A0CB-7E41EC37632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4471"/>
          <a:stretch/>
        </p:blipFill>
        <p:spPr>
          <a:xfrm>
            <a:off x="2267364" y="3892708"/>
            <a:ext cx="6027976" cy="120944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CF50A40-6F2C-6E49-B0A9-F5655C67A249}"/>
              </a:ext>
            </a:extLst>
          </p:cNvPr>
          <p:cNvSpPr txBox="1"/>
          <p:nvPr/>
        </p:nvSpPr>
        <p:spPr>
          <a:xfrm>
            <a:off x="8852916" y="4573150"/>
            <a:ext cx="1439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CU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871382-9D7D-0D48-85DC-98E19B7E2A83}"/>
              </a:ext>
            </a:extLst>
          </p:cNvPr>
          <p:cNvSpPr txBox="1"/>
          <p:nvPr/>
        </p:nvSpPr>
        <p:spPr>
          <a:xfrm>
            <a:off x="3244618" y="673125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A9F71A8-CCFD-3847-8BAC-13CEE9B2DF40}"/>
              </a:ext>
            </a:extLst>
          </p:cNvPr>
          <p:cNvSpPr txBox="1"/>
          <p:nvPr/>
        </p:nvSpPr>
        <p:spPr>
          <a:xfrm>
            <a:off x="6275954" y="670690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484CC3B-A68F-824F-967A-95128F7A036E}"/>
              </a:ext>
            </a:extLst>
          </p:cNvPr>
          <p:cNvSpPr txBox="1"/>
          <p:nvPr/>
        </p:nvSpPr>
        <p:spPr>
          <a:xfrm>
            <a:off x="2696901" y="1186636"/>
            <a:ext cx="3219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 CL  CL  RL  RL  R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52FCC27-9E59-3248-A597-FD34BFE7F4CC}"/>
              </a:ext>
            </a:extLst>
          </p:cNvPr>
          <p:cNvSpPr txBox="1"/>
          <p:nvPr/>
        </p:nvSpPr>
        <p:spPr>
          <a:xfrm>
            <a:off x="5436593" y="1181541"/>
            <a:ext cx="3522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 CL  CL  RL  RL  R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F7E650-F95A-6944-A015-0869A109A43F}"/>
              </a:ext>
            </a:extLst>
          </p:cNvPr>
          <p:cNvSpPr txBox="1"/>
          <p:nvPr/>
        </p:nvSpPr>
        <p:spPr>
          <a:xfrm>
            <a:off x="1678831" y="138442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F06B55-D3D9-0240-87BF-7975D958FCA9}"/>
              </a:ext>
            </a:extLst>
          </p:cNvPr>
          <p:cNvSpPr txBox="1"/>
          <p:nvPr/>
        </p:nvSpPr>
        <p:spPr>
          <a:xfrm>
            <a:off x="1678831" y="1720097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53C9C3-1381-2446-AA40-B80D20B46474}"/>
              </a:ext>
            </a:extLst>
          </p:cNvPr>
          <p:cNvSpPr txBox="1"/>
          <p:nvPr/>
        </p:nvSpPr>
        <p:spPr>
          <a:xfrm>
            <a:off x="1678831" y="201536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A83FFA7-740A-7E45-8873-74D64102BA45}"/>
              </a:ext>
            </a:extLst>
          </p:cNvPr>
          <p:cNvSpPr txBox="1"/>
          <p:nvPr/>
        </p:nvSpPr>
        <p:spPr>
          <a:xfrm>
            <a:off x="1678831" y="225360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AF50E8-8CC3-C444-9E11-FB3ECAB4CBD4}"/>
              </a:ext>
            </a:extLst>
          </p:cNvPr>
          <p:cNvSpPr txBox="1"/>
          <p:nvPr/>
        </p:nvSpPr>
        <p:spPr>
          <a:xfrm>
            <a:off x="1678831" y="2662647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2F66C1-E83C-C746-9BE8-4AA202746607}"/>
              </a:ext>
            </a:extLst>
          </p:cNvPr>
          <p:cNvSpPr txBox="1"/>
          <p:nvPr/>
        </p:nvSpPr>
        <p:spPr>
          <a:xfrm>
            <a:off x="1678831" y="3093011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675124-13CE-6841-AA53-B2EB23484FB7}"/>
              </a:ext>
            </a:extLst>
          </p:cNvPr>
          <p:cNvSpPr txBox="1"/>
          <p:nvPr/>
        </p:nvSpPr>
        <p:spPr>
          <a:xfrm>
            <a:off x="1678831" y="469336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77E1709-E00D-E04B-A81D-6A89BE5776FD}"/>
              </a:ext>
            </a:extLst>
          </p:cNvPr>
          <p:cNvSpPr txBox="1"/>
          <p:nvPr/>
        </p:nvSpPr>
        <p:spPr>
          <a:xfrm>
            <a:off x="1684941" y="374412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03F96ED-E573-AF40-8354-FEE5A4806EEF}"/>
              </a:ext>
            </a:extLst>
          </p:cNvPr>
          <p:cNvCxnSpPr>
            <a:cxnSpLocks/>
          </p:cNvCxnSpPr>
          <p:nvPr/>
        </p:nvCxnSpPr>
        <p:spPr>
          <a:xfrm>
            <a:off x="2696901" y="1083634"/>
            <a:ext cx="233808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B7CE213-3B20-F74B-9C25-2DAF6FF39E94}"/>
              </a:ext>
            </a:extLst>
          </p:cNvPr>
          <p:cNvCxnSpPr>
            <a:cxnSpLocks/>
          </p:cNvCxnSpPr>
          <p:nvPr/>
        </p:nvCxnSpPr>
        <p:spPr>
          <a:xfrm>
            <a:off x="5539798" y="1083634"/>
            <a:ext cx="2261539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188204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5A90B57-ACF8-644D-9459-A00703774C3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803"/>
          <a:stretch/>
        </p:blipFill>
        <p:spPr>
          <a:xfrm>
            <a:off x="2540000" y="1379070"/>
            <a:ext cx="4470400" cy="177053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2D4CF28-FE94-974F-8859-CC34DE6A17C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-163" b="24357"/>
          <a:stretch/>
        </p:blipFill>
        <p:spPr>
          <a:xfrm>
            <a:off x="2554206" y="3335218"/>
            <a:ext cx="4456194" cy="19049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AA27D5-5001-F646-83C4-482A749D070B}"/>
              </a:ext>
            </a:extLst>
          </p:cNvPr>
          <p:cNvSpPr txBox="1"/>
          <p:nvPr/>
        </p:nvSpPr>
        <p:spPr>
          <a:xfrm>
            <a:off x="7585499" y="2209800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yblot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D7638B9-6482-BF43-B3C5-F5B384CAF156}"/>
              </a:ext>
            </a:extLst>
          </p:cNvPr>
          <p:cNvSpPr txBox="1"/>
          <p:nvPr/>
        </p:nvSpPr>
        <p:spPr>
          <a:xfrm>
            <a:off x="7585499" y="4105914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nceau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D03855-2808-9246-9251-2BE4C44F16C6}"/>
              </a:ext>
            </a:extLst>
          </p:cNvPr>
          <p:cNvSpPr txBox="1"/>
          <p:nvPr/>
        </p:nvSpPr>
        <p:spPr>
          <a:xfrm>
            <a:off x="3424570" y="697965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E62E82-3D94-4745-B303-C48F90752CC8}"/>
              </a:ext>
            </a:extLst>
          </p:cNvPr>
          <p:cNvSpPr txBox="1"/>
          <p:nvPr/>
        </p:nvSpPr>
        <p:spPr>
          <a:xfrm>
            <a:off x="4914069" y="697188"/>
            <a:ext cx="26714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D4F99D-3C9C-7945-AD3B-226A10270471}"/>
              </a:ext>
            </a:extLst>
          </p:cNvPr>
          <p:cNvSpPr txBox="1"/>
          <p:nvPr/>
        </p:nvSpPr>
        <p:spPr>
          <a:xfrm>
            <a:off x="2859581" y="1077574"/>
            <a:ext cx="2671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CL  CL RL  RL R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AEB300B-4622-0C4A-9034-9D0DFAA8DA64}"/>
              </a:ext>
            </a:extLst>
          </p:cNvPr>
          <p:cNvSpPr txBox="1"/>
          <p:nvPr/>
        </p:nvSpPr>
        <p:spPr>
          <a:xfrm>
            <a:off x="4626520" y="1069295"/>
            <a:ext cx="26714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 RL  RL  CL CL C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4690B8-F633-C441-9CAB-C9581F9946E9}"/>
              </a:ext>
            </a:extLst>
          </p:cNvPr>
          <p:cNvSpPr txBox="1"/>
          <p:nvPr/>
        </p:nvSpPr>
        <p:spPr>
          <a:xfrm>
            <a:off x="2066554" y="1270000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4C65519-AD00-D04F-8AF6-2ACB8C34F036}"/>
              </a:ext>
            </a:extLst>
          </p:cNvPr>
          <p:cNvSpPr txBox="1"/>
          <p:nvPr/>
        </p:nvSpPr>
        <p:spPr>
          <a:xfrm>
            <a:off x="2066553" y="1432444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EC8BA9-6A1F-5046-94B2-FC2A13F10B81}"/>
              </a:ext>
            </a:extLst>
          </p:cNvPr>
          <p:cNvSpPr txBox="1"/>
          <p:nvPr/>
        </p:nvSpPr>
        <p:spPr>
          <a:xfrm>
            <a:off x="2066552" y="1629046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4FED00-CE69-E644-B269-1A44B349EC35}"/>
              </a:ext>
            </a:extLst>
          </p:cNvPr>
          <p:cNvSpPr txBox="1"/>
          <p:nvPr/>
        </p:nvSpPr>
        <p:spPr>
          <a:xfrm>
            <a:off x="2066552" y="1807551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CB0D0A-339D-EB47-8EDD-F1060649C800}"/>
              </a:ext>
            </a:extLst>
          </p:cNvPr>
          <p:cNvSpPr txBox="1"/>
          <p:nvPr/>
        </p:nvSpPr>
        <p:spPr>
          <a:xfrm>
            <a:off x="2066552" y="2086689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6B3F277-1F92-8D49-AAD6-9CDA8EDA2F6B}"/>
              </a:ext>
            </a:extLst>
          </p:cNvPr>
          <p:cNvSpPr txBox="1"/>
          <p:nvPr/>
        </p:nvSpPr>
        <p:spPr>
          <a:xfrm>
            <a:off x="2066552" y="2445735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A83E17E-EB37-1447-A28F-2ADE2D5628E6}"/>
              </a:ext>
            </a:extLst>
          </p:cNvPr>
          <p:cNvSpPr txBox="1"/>
          <p:nvPr/>
        </p:nvSpPr>
        <p:spPr>
          <a:xfrm>
            <a:off x="2066551" y="2893092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59F9EA9-8934-9446-BF51-2B3B3B0ED85E}"/>
              </a:ext>
            </a:extLst>
          </p:cNvPr>
          <p:cNvSpPr txBox="1"/>
          <p:nvPr/>
        </p:nvSpPr>
        <p:spPr>
          <a:xfrm>
            <a:off x="2066551" y="3862800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D084401-4DB9-714E-9D73-2B663068E634}"/>
              </a:ext>
            </a:extLst>
          </p:cNvPr>
          <p:cNvSpPr txBox="1"/>
          <p:nvPr/>
        </p:nvSpPr>
        <p:spPr>
          <a:xfrm>
            <a:off x="2066551" y="3476899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F92EF27-0273-8A42-9077-2870C43C369A}"/>
              </a:ext>
            </a:extLst>
          </p:cNvPr>
          <p:cNvSpPr txBox="1"/>
          <p:nvPr/>
        </p:nvSpPr>
        <p:spPr>
          <a:xfrm>
            <a:off x="2067065" y="3283949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155D558-926E-EB46-A494-065C9F70AA43}"/>
              </a:ext>
            </a:extLst>
          </p:cNvPr>
          <p:cNvSpPr txBox="1"/>
          <p:nvPr/>
        </p:nvSpPr>
        <p:spPr>
          <a:xfrm>
            <a:off x="2066551" y="4271247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BA7575-FF13-7D42-8ACE-785EA4EEEBEC}"/>
              </a:ext>
            </a:extLst>
          </p:cNvPr>
          <p:cNvSpPr txBox="1"/>
          <p:nvPr/>
        </p:nvSpPr>
        <p:spPr>
          <a:xfrm>
            <a:off x="2066551" y="4923822"/>
            <a:ext cx="604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8A3D21A-6BAB-B642-A139-8B7D66B897CC}"/>
              </a:ext>
            </a:extLst>
          </p:cNvPr>
          <p:cNvCxnSpPr>
            <a:cxnSpLocks/>
          </p:cNvCxnSpPr>
          <p:nvPr/>
        </p:nvCxnSpPr>
        <p:spPr>
          <a:xfrm>
            <a:off x="2859581" y="1069295"/>
            <a:ext cx="1766939" cy="8279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962EDF6-4CEB-CC4F-805B-5538A5D92829}"/>
              </a:ext>
            </a:extLst>
          </p:cNvPr>
          <p:cNvCxnSpPr>
            <a:cxnSpLocks/>
          </p:cNvCxnSpPr>
          <p:nvPr/>
        </p:nvCxnSpPr>
        <p:spPr>
          <a:xfrm>
            <a:off x="4672314" y="1077574"/>
            <a:ext cx="168218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55569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512855B-4800-2143-8432-4BD6EFCA70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830" b="7918"/>
          <a:stretch/>
        </p:blipFill>
        <p:spPr>
          <a:xfrm>
            <a:off x="3700253" y="783824"/>
            <a:ext cx="3760916" cy="47169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F26371D-C162-2847-B7EB-81C6690037F1}"/>
              </a:ext>
            </a:extLst>
          </p:cNvPr>
          <p:cNvSpPr txBox="1"/>
          <p:nvPr/>
        </p:nvSpPr>
        <p:spPr>
          <a:xfrm>
            <a:off x="7528644" y="2192510"/>
            <a:ext cx="1376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yblot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364BEF-D97B-8949-BEBF-506C76C1279F}"/>
              </a:ext>
            </a:extLst>
          </p:cNvPr>
          <p:cNvSpPr txBox="1"/>
          <p:nvPr/>
        </p:nvSpPr>
        <p:spPr>
          <a:xfrm>
            <a:off x="7568520" y="6365203"/>
            <a:ext cx="1376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C318C62-3B14-6440-9025-E41AD8C571D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318" r="8822" b="59761"/>
          <a:stretch/>
        </p:blipFill>
        <p:spPr>
          <a:xfrm>
            <a:off x="3700254" y="5552519"/>
            <a:ext cx="3760916" cy="130548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87D54C9-0C84-C144-8CAD-5EB62CC7128E}"/>
              </a:ext>
            </a:extLst>
          </p:cNvPr>
          <p:cNvSpPr txBox="1"/>
          <p:nvPr/>
        </p:nvSpPr>
        <p:spPr>
          <a:xfrm>
            <a:off x="3099880" y="259112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D9CBE63-404A-3D49-9420-CAA85744AE69}"/>
              </a:ext>
            </a:extLst>
          </p:cNvPr>
          <p:cNvSpPr txBox="1"/>
          <p:nvPr/>
        </p:nvSpPr>
        <p:spPr>
          <a:xfrm>
            <a:off x="3099880" y="331051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19D8B9-467C-9547-9F22-731F2B781268}"/>
              </a:ext>
            </a:extLst>
          </p:cNvPr>
          <p:cNvSpPr txBox="1"/>
          <p:nvPr/>
        </p:nvSpPr>
        <p:spPr>
          <a:xfrm>
            <a:off x="3099880" y="432850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2FACB31-5B9B-EB4E-903A-96B5C6E5407F}"/>
              </a:ext>
            </a:extLst>
          </p:cNvPr>
          <p:cNvSpPr txBox="1"/>
          <p:nvPr/>
        </p:nvSpPr>
        <p:spPr>
          <a:xfrm>
            <a:off x="3099880" y="504821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493503B-26E6-6D40-A725-31100BF46966}"/>
              </a:ext>
            </a:extLst>
          </p:cNvPr>
          <p:cNvSpPr txBox="1"/>
          <p:nvPr/>
        </p:nvSpPr>
        <p:spPr>
          <a:xfrm>
            <a:off x="3099880" y="187173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5B9FF88-884B-FB49-A535-0B97FF8F3DBD}"/>
              </a:ext>
            </a:extLst>
          </p:cNvPr>
          <p:cNvSpPr txBox="1"/>
          <p:nvPr/>
        </p:nvSpPr>
        <p:spPr>
          <a:xfrm>
            <a:off x="3092023" y="152762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BDFFD15-1914-8F4E-AEEA-BA64C86F42EE}"/>
              </a:ext>
            </a:extLst>
          </p:cNvPr>
          <p:cNvSpPr txBox="1"/>
          <p:nvPr/>
        </p:nvSpPr>
        <p:spPr>
          <a:xfrm>
            <a:off x="3092024" y="114130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1709FA-1E50-A847-AD5D-13FD7DAC4690}"/>
              </a:ext>
            </a:extLst>
          </p:cNvPr>
          <p:cNvSpPr txBox="1"/>
          <p:nvPr/>
        </p:nvSpPr>
        <p:spPr>
          <a:xfrm>
            <a:off x="3099880" y="78382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F90B9BF-72E2-1F47-BADA-3186ADE47A4F}"/>
              </a:ext>
            </a:extLst>
          </p:cNvPr>
          <p:cNvSpPr txBox="1"/>
          <p:nvPr/>
        </p:nvSpPr>
        <p:spPr>
          <a:xfrm>
            <a:off x="3103812" y="555251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FC23E63-0C7A-894F-B616-5BDBC907D62D}"/>
              </a:ext>
            </a:extLst>
          </p:cNvPr>
          <p:cNvSpPr txBox="1"/>
          <p:nvPr/>
        </p:nvSpPr>
        <p:spPr>
          <a:xfrm>
            <a:off x="3095954" y="627462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8C44086-AC7F-9448-BFED-B388B4F52528}"/>
              </a:ext>
            </a:extLst>
          </p:cNvPr>
          <p:cNvSpPr txBox="1"/>
          <p:nvPr/>
        </p:nvSpPr>
        <p:spPr>
          <a:xfrm>
            <a:off x="4244996" y="6406"/>
            <a:ext cx="2671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9506793-65A0-3946-B715-0D142C4FB802}"/>
              </a:ext>
            </a:extLst>
          </p:cNvPr>
          <p:cNvSpPr txBox="1"/>
          <p:nvPr/>
        </p:nvSpPr>
        <p:spPr>
          <a:xfrm>
            <a:off x="5896408" y="6406"/>
            <a:ext cx="26714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6BBC685-916C-3647-AA04-48860DDCCBD6}"/>
              </a:ext>
            </a:extLst>
          </p:cNvPr>
          <p:cNvSpPr txBox="1"/>
          <p:nvPr/>
        </p:nvSpPr>
        <p:spPr>
          <a:xfrm>
            <a:off x="4244996" y="437912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F23BAF2-A1F5-6147-853C-88001CD15A06}"/>
              </a:ext>
            </a:extLst>
          </p:cNvPr>
          <p:cNvSpPr txBox="1"/>
          <p:nvPr/>
        </p:nvSpPr>
        <p:spPr>
          <a:xfrm>
            <a:off x="4759234" y="437912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727AD7-239E-4B4D-BD03-271FCCEE4EC3}"/>
              </a:ext>
            </a:extLst>
          </p:cNvPr>
          <p:cNvSpPr txBox="1"/>
          <p:nvPr/>
        </p:nvSpPr>
        <p:spPr>
          <a:xfrm>
            <a:off x="5262082" y="437912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F41E113-B724-0A46-8B21-EA41E505EA53}"/>
              </a:ext>
            </a:extLst>
          </p:cNvPr>
          <p:cNvSpPr txBox="1"/>
          <p:nvPr/>
        </p:nvSpPr>
        <p:spPr>
          <a:xfrm>
            <a:off x="5774465" y="437912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8E3B082-713B-9044-9F3D-34BCD32448A9}"/>
              </a:ext>
            </a:extLst>
          </p:cNvPr>
          <p:cNvSpPr txBox="1"/>
          <p:nvPr/>
        </p:nvSpPr>
        <p:spPr>
          <a:xfrm>
            <a:off x="6284783" y="439403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776CDCA-1CFF-FF4A-97F1-2A159F3999C8}"/>
              </a:ext>
            </a:extLst>
          </p:cNvPr>
          <p:cNvSpPr txBox="1"/>
          <p:nvPr/>
        </p:nvSpPr>
        <p:spPr>
          <a:xfrm>
            <a:off x="6823346" y="437912"/>
            <a:ext cx="5190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8C3FA7FC-2DAD-1E4F-94F4-F33753FE5707}"/>
              </a:ext>
            </a:extLst>
          </p:cNvPr>
          <p:cNvCxnSpPr>
            <a:cxnSpLocks/>
          </p:cNvCxnSpPr>
          <p:nvPr/>
        </p:nvCxnSpPr>
        <p:spPr>
          <a:xfrm>
            <a:off x="4244996" y="357663"/>
            <a:ext cx="90573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2579367-7D3D-154F-AF77-552FEFAADEEA}"/>
              </a:ext>
            </a:extLst>
          </p:cNvPr>
          <p:cNvCxnSpPr>
            <a:cxnSpLocks/>
          </p:cNvCxnSpPr>
          <p:nvPr/>
        </p:nvCxnSpPr>
        <p:spPr>
          <a:xfrm>
            <a:off x="5366254" y="361442"/>
            <a:ext cx="1654344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72002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CA1E40D-77B6-F54C-AA7A-65942AA649C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1194"/>
          <a:stretch/>
        </p:blipFill>
        <p:spPr>
          <a:xfrm>
            <a:off x="2738059" y="955232"/>
            <a:ext cx="3497520" cy="418324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C879D8F-E2F4-2A4B-AEE6-AA267C17472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6106" b="36846"/>
          <a:stretch/>
        </p:blipFill>
        <p:spPr>
          <a:xfrm>
            <a:off x="2754464" y="5296316"/>
            <a:ext cx="3538673" cy="13775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9510C87-B540-B346-9A2A-354C2A7CB9D0}"/>
              </a:ext>
            </a:extLst>
          </p:cNvPr>
          <p:cNvSpPr txBox="1"/>
          <p:nvPr/>
        </p:nvSpPr>
        <p:spPr>
          <a:xfrm>
            <a:off x="7179411" y="2593792"/>
            <a:ext cx="1439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30CF9B-D96A-1C44-B794-99014160C9AC}"/>
              </a:ext>
            </a:extLst>
          </p:cNvPr>
          <p:cNvSpPr txBox="1"/>
          <p:nvPr/>
        </p:nvSpPr>
        <p:spPr>
          <a:xfrm>
            <a:off x="7179411" y="6108439"/>
            <a:ext cx="1439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80877D-E3AA-014F-A662-3B0F16918A92}"/>
              </a:ext>
            </a:extLst>
          </p:cNvPr>
          <p:cNvSpPr txBox="1"/>
          <p:nvPr/>
        </p:nvSpPr>
        <p:spPr>
          <a:xfrm>
            <a:off x="2127406" y="2689625"/>
            <a:ext cx="6042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A8198E-EC97-994A-963E-10D14B3E3B96}"/>
              </a:ext>
            </a:extLst>
          </p:cNvPr>
          <p:cNvSpPr txBox="1"/>
          <p:nvPr/>
        </p:nvSpPr>
        <p:spPr>
          <a:xfrm>
            <a:off x="2133760" y="191972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4BADFE-DB1E-0045-BF09-AA025E3AFD04}"/>
              </a:ext>
            </a:extLst>
          </p:cNvPr>
          <p:cNvSpPr txBox="1"/>
          <p:nvPr/>
        </p:nvSpPr>
        <p:spPr>
          <a:xfrm>
            <a:off x="2127407" y="159336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57DF8C-719E-1846-B090-FA7CD01D9672}"/>
              </a:ext>
            </a:extLst>
          </p:cNvPr>
          <p:cNvSpPr txBox="1"/>
          <p:nvPr/>
        </p:nvSpPr>
        <p:spPr>
          <a:xfrm>
            <a:off x="2127408" y="122403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4D47115-41FE-E143-B608-A78A9EF3D822}"/>
              </a:ext>
            </a:extLst>
          </p:cNvPr>
          <p:cNvSpPr txBox="1"/>
          <p:nvPr/>
        </p:nvSpPr>
        <p:spPr>
          <a:xfrm>
            <a:off x="2130584" y="89767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DA6B685-375B-9043-B325-F27EAC05459C}"/>
              </a:ext>
            </a:extLst>
          </p:cNvPr>
          <p:cNvSpPr txBox="1"/>
          <p:nvPr/>
        </p:nvSpPr>
        <p:spPr>
          <a:xfrm>
            <a:off x="2136935" y="529631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C8652DB-48E0-8E43-8DB4-994296FF94F9}"/>
              </a:ext>
            </a:extLst>
          </p:cNvPr>
          <p:cNvSpPr txBox="1"/>
          <p:nvPr/>
        </p:nvSpPr>
        <p:spPr>
          <a:xfrm>
            <a:off x="2133760" y="592377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0DB497-D38E-274B-A735-284DEE8F333D}"/>
              </a:ext>
            </a:extLst>
          </p:cNvPr>
          <p:cNvSpPr txBox="1"/>
          <p:nvPr/>
        </p:nvSpPr>
        <p:spPr>
          <a:xfrm>
            <a:off x="2127405" y="426879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AABB46A-CCA7-0E40-B618-A2D008FE3F32}"/>
              </a:ext>
            </a:extLst>
          </p:cNvPr>
          <p:cNvSpPr txBox="1"/>
          <p:nvPr/>
        </p:nvSpPr>
        <p:spPr>
          <a:xfrm>
            <a:off x="2127405" y="4769142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81708EE-C3B6-5E45-BF47-48E12721BA93}"/>
              </a:ext>
            </a:extLst>
          </p:cNvPr>
          <p:cNvSpPr txBox="1"/>
          <p:nvPr/>
        </p:nvSpPr>
        <p:spPr>
          <a:xfrm>
            <a:off x="3421820" y="297828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2456B78-7898-D748-A3C9-523BD17C79CC}"/>
              </a:ext>
            </a:extLst>
          </p:cNvPr>
          <p:cNvSpPr txBox="1"/>
          <p:nvPr/>
        </p:nvSpPr>
        <p:spPr>
          <a:xfrm>
            <a:off x="4257126" y="287581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ED5B0D-397D-8E49-8A76-CB6E2825BC3B}"/>
              </a:ext>
            </a:extLst>
          </p:cNvPr>
          <p:cNvSpPr txBox="1"/>
          <p:nvPr/>
        </p:nvSpPr>
        <p:spPr>
          <a:xfrm>
            <a:off x="4976686" y="287581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1AB692B-666D-FC4D-9E96-590F4384C619}"/>
              </a:ext>
            </a:extLst>
          </p:cNvPr>
          <p:cNvSpPr txBox="1"/>
          <p:nvPr/>
        </p:nvSpPr>
        <p:spPr>
          <a:xfrm>
            <a:off x="5635478" y="287581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24195F2-B694-584E-A916-07244F8B9287}"/>
              </a:ext>
            </a:extLst>
          </p:cNvPr>
          <p:cNvCxnSpPr>
            <a:cxnSpLocks/>
          </p:cNvCxnSpPr>
          <p:nvPr/>
        </p:nvCxnSpPr>
        <p:spPr>
          <a:xfrm>
            <a:off x="3361932" y="609559"/>
            <a:ext cx="758655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A1E8CBB-E9A9-9F4E-A8EB-E1552B7B28AB}"/>
              </a:ext>
            </a:extLst>
          </p:cNvPr>
          <p:cNvCxnSpPr>
            <a:cxnSpLocks/>
          </p:cNvCxnSpPr>
          <p:nvPr/>
        </p:nvCxnSpPr>
        <p:spPr>
          <a:xfrm>
            <a:off x="4872214" y="615210"/>
            <a:ext cx="758655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8CD77C3-3102-0244-BBC8-35264364E65A}"/>
              </a:ext>
            </a:extLst>
          </p:cNvPr>
          <p:cNvCxnSpPr>
            <a:cxnSpLocks/>
          </p:cNvCxnSpPr>
          <p:nvPr/>
        </p:nvCxnSpPr>
        <p:spPr>
          <a:xfrm>
            <a:off x="4257126" y="605605"/>
            <a:ext cx="39354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4D05AC0-7BC5-534D-B477-20E02F0C872B}"/>
              </a:ext>
            </a:extLst>
          </p:cNvPr>
          <p:cNvCxnSpPr>
            <a:cxnSpLocks/>
          </p:cNvCxnSpPr>
          <p:nvPr/>
        </p:nvCxnSpPr>
        <p:spPr>
          <a:xfrm>
            <a:off x="5702460" y="605605"/>
            <a:ext cx="39354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1BC3AD8-36C5-3246-98B5-8C67871C903F}"/>
              </a:ext>
            </a:extLst>
          </p:cNvPr>
          <p:cNvSpPr txBox="1"/>
          <p:nvPr/>
        </p:nvSpPr>
        <p:spPr>
          <a:xfrm>
            <a:off x="3339917" y="681228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32A6659-6A93-4B41-8F99-43C4463345F6}"/>
              </a:ext>
            </a:extLst>
          </p:cNvPr>
          <p:cNvSpPr txBox="1"/>
          <p:nvPr/>
        </p:nvSpPr>
        <p:spPr>
          <a:xfrm>
            <a:off x="3847983" y="682339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6D72FC0-3D66-9E44-8305-857D6FB214B1}"/>
              </a:ext>
            </a:extLst>
          </p:cNvPr>
          <p:cNvSpPr txBox="1"/>
          <p:nvPr/>
        </p:nvSpPr>
        <p:spPr>
          <a:xfrm>
            <a:off x="4346292" y="683033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3C541E4-DD9E-1744-A4DA-4B17F22FB88A}"/>
              </a:ext>
            </a:extLst>
          </p:cNvPr>
          <p:cNvSpPr txBox="1"/>
          <p:nvPr/>
        </p:nvSpPr>
        <p:spPr>
          <a:xfrm>
            <a:off x="4818207" y="687981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51DEB8F-0888-3E48-9159-006D3922F5A6}"/>
              </a:ext>
            </a:extLst>
          </p:cNvPr>
          <p:cNvSpPr txBox="1"/>
          <p:nvPr/>
        </p:nvSpPr>
        <p:spPr>
          <a:xfrm>
            <a:off x="5299136" y="687981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894BFB8-72D9-544B-B170-D7DB6543F316}"/>
              </a:ext>
            </a:extLst>
          </p:cNvPr>
          <p:cNvSpPr txBox="1"/>
          <p:nvPr/>
        </p:nvSpPr>
        <p:spPr>
          <a:xfrm>
            <a:off x="5754009" y="688656"/>
            <a:ext cx="8026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p:txBody>
      </p:sp>
    </p:spTree>
    <p:extLst>
      <p:ext uri="{BB962C8B-B14F-4D97-AF65-F5344CB8AC3E}">
        <p14:creationId xmlns:p14="http://schemas.microsoft.com/office/powerpoint/2010/main" val="39095485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EFDC31B-DD9A-C448-8945-40A2FA51B41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3000"/>
                    </a14:imgEffect>
                  </a14:imgLayer>
                </a14:imgProps>
              </a:ext>
            </a:extLst>
          </a:blip>
          <a:srcRect l="2986" t="4593" r="2956" b="15843"/>
          <a:stretch/>
        </p:blipFill>
        <p:spPr>
          <a:xfrm>
            <a:off x="2543715" y="1329257"/>
            <a:ext cx="4575674" cy="281880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296BEFC-2B8D-9B49-BFFB-CF20B99208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78835" y="4236208"/>
            <a:ext cx="4717308" cy="11239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E9799B8-93E1-A543-82F3-89CDF12BF18B}"/>
              </a:ext>
            </a:extLst>
          </p:cNvPr>
          <p:cNvSpPr txBox="1"/>
          <p:nvPr/>
        </p:nvSpPr>
        <p:spPr>
          <a:xfrm>
            <a:off x="7469740" y="2643653"/>
            <a:ext cx="1376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N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CCBB2D-2516-6346-9D04-52DBD2391602}"/>
              </a:ext>
            </a:extLst>
          </p:cNvPr>
          <p:cNvSpPr txBox="1"/>
          <p:nvPr/>
        </p:nvSpPr>
        <p:spPr>
          <a:xfrm>
            <a:off x="7325806" y="4694183"/>
            <a:ext cx="1376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D29FBF7-A21B-D549-859D-339E70FB3DC0}"/>
              </a:ext>
            </a:extLst>
          </p:cNvPr>
          <p:cNvSpPr txBox="1"/>
          <p:nvPr/>
        </p:nvSpPr>
        <p:spPr>
          <a:xfrm>
            <a:off x="5525035" y="642002"/>
            <a:ext cx="3488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W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054BDD-2004-AF49-A2A5-7975522BDD15}"/>
              </a:ext>
            </a:extLst>
          </p:cNvPr>
          <p:cNvSpPr txBox="1"/>
          <p:nvPr/>
        </p:nvSpPr>
        <p:spPr>
          <a:xfrm>
            <a:off x="3211312" y="645279"/>
            <a:ext cx="3488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dentar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C231638-BE69-2447-9CFF-9C74B7110DF0}"/>
              </a:ext>
            </a:extLst>
          </p:cNvPr>
          <p:cNvSpPr txBox="1"/>
          <p:nvPr/>
        </p:nvSpPr>
        <p:spPr>
          <a:xfrm>
            <a:off x="2802508" y="1022637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 CL   CL  RL RL  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9B1D2C-5B19-9D40-B263-F7EBD7858EFD}"/>
              </a:ext>
            </a:extLst>
          </p:cNvPr>
          <p:cNvSpPr txBox="1"/>
          <p:nvPr/>
        </p:nvSpPr>
        <p:spPr>
          <a:xfrm>
            <a:off x="4837489" y="1006585"/>
            <a:ext cx="34882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CL  CL  CL  RL  RL  R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387628-268D-9D42-8436-B7A770AEC680}"/>
              </a:ext>
            </a:extLst>
          </p:cNvPr>
          <p:cNvSpPr txBox="1"/>
          <p:nvPr/>
        </p:nvSpPr>
        <p:spPr>
          <a:xfrm>
            <a:off x="2014105" y="420641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3AB2274-25A0-5F4A-8A77-C84B3B65E827}"/>
              </a:ext>
            </a:extLst>
          </p:cNvPr>
          <p:cNvSpPr txBox="1"/>
          <p:nvPr/>
        </p:nvSpPr>
        <p:spPr>
          <a:xfrm>
            <a:off x="2014104" y="4663490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CC71573-6572-8F4B-B1FF-FD7AE49D40B7}"/>
              </a:ext>
            </a:extLst>
          </p:cNvPr>
          <p:cNvSpPr txBox="1"/>
          <p:nvPr/>
        </p:nvSpPr>
        <p:spPr>
          <a:xfrm>
            <a:off x="2018033" y="2274321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1605E08-5EB4-654D-9BA7-629CEBBC3EDD}"/>
              </a:ext>
            </a:extLst>
          </p:cNvPr>
          <p:cNvSpPr txBox="1"/>
          <p:nvPr/>
        </p:nvSpPr>
        <p:spPr>
          <a:xfrm>
            <a:off x="2018033" y="2673344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90CEAF5-1699-A24E-9469-75590DB522C7}"/>
              </a:ext>
            </a:extLst>
          </p:cNvPr>
          <p:cNvSpPr txBox="1"/>
          <p:nvPr/>
        </p:nvSpPr>
        <p:spPr>
          <a:xfrm>
            <a:off x="2018032" y="3377553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AF9772-BB14-3D49-B61B-6374705EBF17}"/>
              </a:ext>
            </a:extLst>
          </p:cNvPr>
          <p:cNvSpPr txBox="1"/>
          <p:nvPr/>
        </p:nvSpPr>
        <p:spPr>
          <a:xfrm>
            <a:off x="2014105" y="3815325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FD19B4E-6780-1244-BDBE-8727D10737F2}"/>
              </a:ext>
            </a:extLst>
          </p:cNvPr>
          <p:cNvSpPr txBox="1"/>
          <p:nvPr/>
        </p:nvSpPr>
        <p:spPr>
          <a:xfrm>
            <a:off x="2018030" y="1825179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0B2862E-F89E-F347-9615-499518D5D59A}"/>
              </a:ext>
            </a:extLst>
          </p:cNvPr>
          <p:cNvSpPr txBox="1"/>
          <p:nvPr/>
        </p:nvSpPr>
        <p:spPr>
          <a:xfrm>
            <a:off x="2018029" y="1600608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D7007D3-8624-C24D-B66E-871356659B16}"/>
              </a:ext>
            </a:extLst>
          </p:cNvPr>
          <p:cNvSpPr txBox="1"/>
          <p:nvPr/>
        </p:nvSpPr>
        <p:spPr>
          <a:xfrm>
            <a:off x="2018029" y="1401097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299068-09E4-F84E-B0FC-ED1D74E465A9}"/>
              </a:ext>
            </a:extLst>
          </p:cNvPr>
          <p:cNvSpPr txBox="1"/>
          <p:nvPr/>
        </p:nvSpPr>
        <p:spPr>
          <a:xfrm>
            <a:off x="2014105" y="1176526"/>
            <a:ext cx="604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4CC687-E7F5-8B44-83FA-4B2977BF8476}"/>
              </a:ext>
            </a:extLst>
          </p:cNvPr>
          <p:cNvSpPr txBox="1"/>
          <p:nvPr/>
        </p:nvSpPr>
        <p:spPr>
          <a:xfrm>
            <a:off x="5552830" y="5418493"/>
            <a:ext cx="20575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 VWR-2 sample handling error, excluded as an outlier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7E567FB-DB68-514C-A1F9-8D3E6DCE1795}"/>
              </a:ext>
            </a:extLst>
          </p:cNvPr>
          <p:cNvCxnSpPr>
            <a:cxnSpLocks/>
          </p:cNvCxnSpPr>
          <p:nvPr/>
        </p:nvCxnSpPr>
        <p:spPr>
          <a:xfrm>
            <a:off x="2889813" y="1006585"/>
            <a:ext cx="177478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8FC88CE6-4349-2D4A-BD8A-8F4008E53085}"/>
              </a:ext>
            </a:extLst>
          </p:cNvPr>
          <p:cNvCxnSpPr>
            <a:cxnSpLocks/>
          </p:cNvCxnSpPr>
          <p:nvPr/>
        </p:nvCxnSpPr>
        <p:spPr>
          <a:xfrm>
            <a:off x="4986096" y="999463"/>
            <a:ext cx="1766939" cy="8279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206A07F-86DE-924E-B5E7-9C8FE8949FB4}"/>
              </a:ext>
            </a:extLst>
          </p:cNvPr>
          <p:cNvSpPr txBox="1"/>
          <p:nvPr/>
        </p:nvSpPr>
        <p:spPr>
          <a:xfrm>
            <a:off x="5412157" y="5402441"/>
            <a:ext cx="20575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918433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9</TotalTime>
  <Words>487</Words>
  <Application>Microsoft Macintosh PowerPoint</Application>
  <PresentationFormat>Widescreen</PresentationFormat>
  <Paragraphs>171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O'Connor</dc:creator>
  <cp:lastModifiedBy>Thomas O'Connor</cp:lastModifiedBy>
  <cp:revision>19</cp:revision>
  <dcterms:created xsi:type="dcterms:W3CDTF">2022-02-08T02:24:11Z</dcterms:created>
  <dcterms:modified xsi:type="dcterms:W3CDTF">2022-02-11T19:06:35Z</dcterms:modified>
</cp:coreProperties>
</file>